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380413" cy="3430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7D32A-6D94-4ED4-8541-93950FFA82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712476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200" y="2066760"/>
            <a:ext cx="712476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212DB-C0D1-4142-A7E5-9181F8E235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278960" y="99180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200" y="206676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278960" y="206676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4F9A6-07AA-4542-8A0F-4A5A28BE26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22939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37320" y="991800"/>
            <a:ext cx="22939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446080" y="991800"/>
            <a:ext cx="22939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200" y="2066760"/>
            <a:ext cx="22939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37320" y="2066760"/>
            <a:ext cx="22939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446080" y="2066760"/>
            <a:ext cx="22939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6FAF5-4684-4B4F-B425-A8441D5938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200" y="991800"/>
            <a:ext cx="7124760" cy="2057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4964B-985A-454A-A21B-B7842D3FD9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7124760" cy="20574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16781C-4176-4070-A440-0CFBA7D389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3476520" cy="20574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278960" y="991800"/>
            <a:ext cx="3476520" cy="20574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CE621-FE99-4655-8B93-7FC7CCF16A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AAB1D-2671-4541-A3D2-3B35F60E69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200" y="306360"/>
            <a:ext cx="7124760" cy="26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D4D97-DA24-445E-8C22-9E02FF2738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278960" y="991800"/>
            <a:ext cx="3476520" cy="20574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200" y="206676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AE53B-A4C0-4D8D-94EC-9548E0FC19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3476520" cy="20574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278960" y="99180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278960" y="206676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9796F-B216-49AB-928D-CB91FD8B99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200" y="99180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278960" y="991800"/>
            <a:ext cx="347652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200" y="2066760"/>
            <a:ext cx="7124760" cy="98136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9F0CC-1D23-44E7-AE9D-F3910D14E8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200" y="306360"/>
            <a:ext cx="7124760" cy="57168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200" y="991800"/>
            <a:ext cx="7124760" cy="20574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rmAutofit fontScale="66000"/>
          </a:bodyPr>
          <a:p>
            <a:pPr marL="169560" indent="-169560">
              <a:spcBef>
                <a:spcPts val="601"/>
              </a:spcBef>
              <a:buClr>
                <a:srgbClr val="000000"/>
              </a:buClr>
              <a:buFont typeface="Times New Roman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367560" indent="-141120">
              <a:spcBef>
                <a:spcPts val="601"/>
              </a:spcBef>
              <a:buClr>
                <a:srgbClr val="000000"/>
              </a:buClr>
              <a:buFont typeface="Times New Roman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2" marL="565560" indent="-113040">
              <a:spcBef>
                <a:spcPts val="601"/>
              </a:spcBef>
              <a:buClr>
                <a:srgbClr val="000000"/>
              </a:buClr>
              <a:buFont typeface="Times New Roman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3" marL="792000" indent="-113040">
              <a:spcBef>
                <a:spcPts val="601"/>
              </a:spcBef>
              <a:buClr>
                <a:srgbClr val="000000"/>
              </a:buClr>
              <a:buFont typeface="Times New Roman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4" marL="1018080" indent="-113040">
              <a:spcBef>
                <a:spcPts val="601"/>
              </a:spcBef>
              <a:buClr>
                <a:srgbClr val="000000"/>
              </a:buClr>
              <a:buFont typeface="Times New Roman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5" marL="1018080" indent="-113040">
              <a:spcBef>
                <a:spcPts val="601"/>
              </a:spcBef>
              <a:buClr>
                <a:srgbClr val="000000"/>
              </a:buClr>
              <a:buFont typeface="Times New Roman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6" marL="1018080" indent="-113040">
              <a:spcBef>
                <a:spcPts val="601"/>
              </a:spcBef>
              <a:buClr>
                <a:srgbClr val="000000"/>
              </a:buClr>
              <a:buFont typeface="Times New Roman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3122280"/>
            <a:ext cx="1746360" cy="2286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Autofit/>
          </a:bodyPr>
          <a:lstStyle>
            <a:lvl1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863440" y="3122280"/>
            <a:ext cx="2654280" cy="2286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Autofit/>
          </a:bodyPr>
          <a:lstStyle>
            <a:lvl1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006600" y="3122280"/>
            <a:ext cx="1746360" cy="228600"/>
          </a:xfrm>
          <a:prstGeom prst="rect">
            <a:avLst/>
          </a:prstGeom>
          <a:noFill/>
          <a:ln w="0">
            <a:noFill/>
          </a:ln>
        </p:spPr>
        <p:txBody>
          <a:bodyPr lIns="68760" rIns="68760" tIns="34200" bIns="34200" anchor="t">
            <a:noAutofit/>
          </a:bodyPr>
          <a:lstStyle>
            <a:lvl1pPr indent="0" algn="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fld id="{4C220B62-15B5-4990-97F0-065F36968D2A}" type="slidenum"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718080" y="596880"/>
            <a:ext cx="74520" cy="754200"/>
          </a:xfrm>
          <a:prstGeom prst="rect">
            <a:avLst/>
          </a:prstGeom>
          <a:solidFill>
            <a:srgbClr val="cc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6665760" y="2725560"/>
            <a:ext cx="74880" cy="204840"/>
          </a:xfrm>
          <a:prstGeom prst="rect">
            <a:avLst/>
          </a:prstGeom>
          <a:solidFill>
            <a:srgbClr val="ff99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665760" y="1882800"/>
            <a:ext cx="74880" cy="853920"/>
          </a:xfrm>
          <a:prstGeom prst="rect">
            <a:avLst/>
          </a:prstGeom>
          <a:solidFill>
            <a:srgbClr val="cc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2176560" y="1889280"/>
            <a:ext cx="4400280" cy="1022040"/>
          </a:xfrm>
          <a:prstGeom prst="rect">
            <a:avLst/>
          </a:prstGeom>
          <a:solidFill>
            <a:srgbClr val="ff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2163600" y="593640"/>
            <a:ext cx="1473480" cy="762120"/>
          </a:xfrm>
          <a:prstGeom prst="rect">
            <a:avLst/>
          </a:prstGeom>
          <a:solidFill>
            <a:srgbClr val="ff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88200" y="9360"/>
            <a:ext cx="818172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tcttcctctctcttttataaaagGAAAAAATACCCCTGGAAAGCCAATGAGAGAGgttagtgagat---tcaggctcacggccat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Mouse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tcttcctctctctattattaaagGAAGAAATGCCCCCGGAAAGCCAATGAGAGAGgttagtgagac---tcaggcgcacagccat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tcttcccctctctgttattaaagGAAGAAATGCCCCTGGAAAGCCAATGAGAGAGgttagtgagat---tcaggctcactgccat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acttcctctctctgttcctaaagGAAGAAATGCCCCTGGAAAGCCAGTGAGAGAGgttagtgagat---gcaagctcactgccat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Frog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tcttcctctctctattattttagGAAGAAATACCCCTGGAAAGCCAATGAGAGAGgttagtgagat---tcaggctcacggccatg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Zebrafish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ttccccttttcctctgtct-aagGAGGCGGACGGCT---AAATCCA---TGAGAGgttagtattgtaactaac-ctttcagtcttc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Fugu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tcctctttttgtctgtgacccagCAGGGAGAAGGGG------ACACCTGTGAGAGgttagttgcttatctttc-ttctctgcacac</a:t>
            </a:r>
            <a:r>
              <a:rPr b="0" lang="en-US" sz="6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Shark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accttttctacctatcactaaagTGAGGGATTCCTATGGAAAGCAAGTGAAAGAGgttggtgagacaactcactgccagagcaatg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α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tctttccccctgccctgtttcagGATACAGTACAGCCTGAATGTGGCAGACAGGCTAGCTGATGAACATGTTCTCATCGGGTTGTATGTCAACATGCTCCGGAACAACCCC---TCATGgttagtgcaggtttggctgcttgactgtccttaga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α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ctttgctcccacccctgtttcagGTTACACTACAGCCTGGATGTGGCAGACAGGCTAGCTGATGAACATGTTCTCATCGGGTTGTATGTCAACATGCTTCAGAGCAACCCC---TCACGgttagtgcaggtttggcacctgggcacccaagctt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α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ctctctccccgcccccgctccagGTTACAGTACAGCCTCGATGTTGCAGACAGGCTGGCCGATGAACATGTGCTCATTGGGTTGTATGTCAACATGCTGCAGAGCAACCCC---GCACGgttagtgcaggtttggcacttcggggggatccagg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Zebrafish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α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ttgtttctgatacatggtttcagGGTTCAGTACAGCCTCGATATTGCTGATAGGCTCGCAGATGAGCACATACTGATCGGACTTTATGTGAATCTTCTGCAGAAGGAGCGA---TCATGgtcagtgtgagctgtccgcctgatggttgctgtgt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Fugu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α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ctgtgacgtgctgcactgtttcagGCTGAACTACAACCTCGACGTTGCCGATAGACTCGCTGACGAACACGCTCTGATTGGCCTGTATGTGAATCTGCTCCAAAACAAGCCCAAATCATGgttagtcagcgtggtgggcacggattgctcagctc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β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gtctttgcctccattgttcctagGTTACAGTATAGCCAGGATATACCCAGTCACTTGGCCGATGAGCATGCGCTGATAGCCTCCTATGTGGCCCGTCTGCAGCACTGTGCA------CGgtcagtggtggtgcagcagcagtgggtagccacgg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β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gtctttgcctccatttttcccagGTTACAGTATAGCCAGGAAATACCCAGTCACTTGGCTGATGAGCATGCACTGATAGCTTCCTATGTGTCCCGTCTACAGCACTGTGCA------CGgtcagtgtttgaacagcagttgggcttatgaaggg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β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ctttttgcctccaccatcaccagGTTGCAGTGCAAGGCGGACGCTGCTGGCCGATTGGCTGATGAGCATGCACTGATTGCAACCTATGTGAGCCGGCTGCAGCACGGGGCA------CGgttagtgctaggagagcttctcatttccaccctca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Frog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β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tttctttaccctggttgtcactagGTTGCACAACAGTGCAGACACGGCCAGTCGGGTACCAGACGAGCACGCGCTGATAGCAGAGTATGTGGCACGACTCCGCTTCGGCACA------CGgttagtgttaggaaccttagttcagaccaaaatgg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Zebrafish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γ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aacttgggttttgtgtgtgttcagACTGCCG---ACTCTGGCTGCAGCTCAGCGAATGAATGAAGAACATGCTCTGATCGCTGCGTATGTCAACAAACTCCAGAGCAGCCCA------CGgtgagtgtgtgtgtgtgtctttgagggagagtgct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Fugu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 γ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</a:rPr>
              <a:t>gcgctctgatgttctccttctcagT------------GTGGCAGCCGCCCCGCGTGCCAGCGAGGAGCACGCTCTGATCGCAGCCTATGTGGATCGCCTCCAGAGCACGCCA------TGgtaggagcggttgggtatcttcagtggtggggcat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316960" y="357120"/>
            <a:ext cx="128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Dystrophin Exon 7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37160" y="2444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40040" y="15397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3492360" y="1658880"/>
            <a:ext cx="1390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Dystrobrevin Exon 1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2182680" y="1876320"/>
            <a:ext cx="4419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2170080" y="2911320"/>
            <a:ext cx="4419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182680" y="587520"/>
            <a:ext cx="1447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189160" y="1355760"/>
            <a:ext cx="1447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745080" y="282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517920" y="84240"/>
            <a:ext cx="40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+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6691320" y="157788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6473880" y="1379520"/>
            <a:ext cx="40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+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6691320" y="291096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6519240" y="3138480"/>
            <a:ext cx="41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+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7-21T14:34:58Z</dcterms:created>
  <dc:creator>Roberts</dc:creator>
  <dc:description/>
  <dc:language>en-US</dc:language>
  <cp:lastModifiedBy>Roberts</cp:lastModifiedBy>
  <cp:lastPrinted>2006-07-21T14:42:57Z</cp:lastPrinted>
  <dcterms:modified xsi:type="dcterms:W3CDTF">2007-01-16T16:01:27Z</dcterms:modified>
  <cp:revision>6</cp:revision>
  <dc:subject/>
  <dc:title>No Slide Title</dc:title>
</cp:coreProperties>
</file>